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924" r:id="rId1"/>
  </p:sldMasterIdLst>
  <p:notesMasterIdLst>
    <p:notesMasterId r:id="rId3"/>
  </p:notesMasterIdLst>
  <p:sldIdLst>
    <p:sldId id="276" r:id="rId2"/>
  </p:sldIdLst>
  <p:sldSz cx="10515600" cy="3657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76"/>
    <p:restoredTop sz="95645"/>
  </p:normalViewPr>
  <p:slideViewPr>
    <p:cSldViewPr snapToGrid="0" snapToObjects="1">
      <p:cViewPr varScale="1">
        <p:scale>
          <a:sx n="168" d="100"/>
          <a:sy n="168" d="100"/>
        </p:scale>
        <p:origin x="232" y="9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03A0AC-7C94-3B49-B02F-CE42D7991C4D}" type="datetimeFigureOut">
              <a:rPr lang="en-US" smtClean="0"/>
              <a:t>9/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006475" y="1143000"/>
            <a:ext cx="8870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1A0742-5874-F644-86F4-073385C1AF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491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14450" y="598593"/>
            <a:ext cx="7886700" cy="1273387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14450" y="1921087"/>
            <a:ext cx="7886700" cy="883073"/>
          </a:xfrm>
        </p:spPr>
        <p:txBody>
          <a:bodyPr/>
          <a:lstStyle>
            <a:lvl1pPr marL="0" indent="0" algn="ctr">
              <a:buNone/>
              <a:defRPr sz="1280"/>
            </a:lvl1pPr>
            <a:lvl2pPr marL="243825" indent="0" algn="ctr">
              <a:buNone/>
              <a:defRPr sz="1067"/>
            </a:lvl2pPr>
            <a:lvl3pPr marL="487650" indent="0" algn="ctr">
              <a:buNone/>
              <a:defRPr sz="960"/>
            </a:lvl3pPr>
            <a:lvl4pPr marL="731474" indent="0" algn="ctr">
              <a:buNone/>
              <a:defRPr sz="853"/>
            </a:lvl4pPr>
            <a:lvl5pPr marL="975299" indent="0" algn="ctr">
              <a:buNone/>
              <a:defRPr sz="853"/>
            </a:lvl5pPr>
            <a:lvl6pPr marL="1219124" indent="0" algn="ctr">
              <a:buNone/>
              <a:defRPr sz="853"/>
            </a:lvl6pPr>
            <a:lvl7pPr marL="1462949" indent="0" algn="ctr">
              <a:buNone/>
              <a:defRPr sz="853"/>
            </a:lvl7pPr>
            <a:lvl8pPr marL="1706773" indent="0" algn="ctr">
              <a:buNone/>
              <a:defRPr sz="853"/>
            </a:lvl8pPr>
            <a:lvl9pPr marL="1950598" indent="0" algn="ctr">
              <a:buNone/>
              <a:defRPr sz="85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174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089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525226" y="194733"/>
            <a:ext cx="2267426" cy="3099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2947" y="194733"/>
            <a:ext cx="6670834" cy="3099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81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191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7471" y="911860"/>
            <a:ext cx="9069705" cy="15214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471" y="2447714"/>
            <a:ext cx="9069705" cy="800100"/>
          </a:xfrm>
        </p:spPr>
        <p:txBody>
          <a:bodyPr/>
          <a:lstStyle>
            <a:lvl1pPr marL="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1pPr>
            <a:lvl2pPr marL="243825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2pPr>
            <a:lvl3pPr marL="48765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3pPr>
            <a:lvl4pPr marL="73147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4pPr>
            <a:lvl5pPr marL="97529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5pPr>
            <a:lvl6pPr marL="121912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6pPr>
            <a:lvl7pPr marL="146294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7pPr>
            <a:lvl8pPr marL="1706773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8pPr>
            <a:lvl9pPr marL="1950598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111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2948" y="973666"/>
            <a:ext cx="4469130" cy="2320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23523" y="973666"/>
            <a:ext cx="4469130" cy="2320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3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7" y="194734"/>
            <a:ext cx="9069705" cy="7069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4318" y="896620"/>
            <a:ext cx="4448591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4318" y="1336040"/>
            <a:ext cx="4448591" cy="19651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23522" y="896620"/>
            <a:ext cx="4470500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23522" y="1336040"/>
            <a:ext cx="4470500" cy="19651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29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030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12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8" y="243840"/>
            <a:ext cx="3391554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70499" y="526627"/>
            <a:ext cx="5323523" cy="2599267"/>
          </a:xfrm>
        </p:spPr>
        <p:txBody>
          <a:bodyPr/>
          <a:lstStyle>
            <a:lvl1pPr>
              <a:defRPr sz="1707"/>
            </a:lvl1pPr>
            <a:lvl2pPr>
              <a:defRPr sz="1493"/>
            </a:lvl2pPr>
            <a:lvl3pPr>
              <a:defRPr sz="1280"/>
            </a:lvl3pPr>
            <a:lvl4pPr>
              <a:defRPr sz="1067"/>
            </a:lvl4pPr>
            <a:lvl5pPr>
              <a:defRPr sz="1067"/>
            </a:lvl5pPr>
            <a:lvl6pPr>
              <a:defRPr sz="1067"/>
            </a:lvl6pPr>
            <a:lvl7pPr>
              <a:defRPr sz="1067"/>
            </a:lvl7pPr>
            <a:lvl8pPr>
              <a:defRPr sz="1067"/>
            </a:lvl8pPr>
            <a:lvl9pPr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4318" y="1097280"/>
            <a:ext cx="3391554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03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8" y="243840"/>
            <a:ext cx="3391554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70499" y="526627"/>
            <a:ext cx="5323523" cy="2599267"/>
          </a:xfrm>
        </p:spPr>
        <p:txBody>
          <a:bodyPr anchor="t"/>
          <a:lstStyle>
            <a:lvl1pPr marL="0" indent="0">
              <a:buNone/>
              <a:defRPr sz="1707"/>
            </a:lvl1pPr>
            <a:lvl2pPr marL="243825" indent="0">
              <a:buNone/>
              <a:defRPr sz="1493"/>
            </a:lvl2pPr>
            <a:lvl3pPr marL="487650" indent="0">
              <a:buNone/>
              <a:defRPr sz="1280"/>
            </a:lvl3pPr>
            <a:lvl4pPr marL="731474" indent="0">
              <a:buNone/>
              <a:defRPr sz="1067"/>
            </a:lvl4pPr>
            <a:lvl5pPr marL="975299" indent="0">
              <a:buNone/>
              <a:defRPr sz="1067"/>
            </a:lvl5pPr>
            <a:lvl6pPr marL="1219124" indent="0">
              <a:buNone/>
              <a:defRPr sz="1067"/>
            </a:lvl6pPr>
            <a:lvl7pPr marL="1462949" indent="0">
              <a:buNone/>
              <a:defRPr sz="1067"/>
            </a:lvl7pPr>
            <a:lvl8pPr marL="1706773" indent="0">
              <a:buNone/>
              <a:defRPr sz="1067"/>
            </a:lvl8pPr>
            <a:lvl9pPr marL="1950598" indent="0">
              <a:buNone/>
              <a:defRPr sz="10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4318" y="1097280"/>
            <a:ext cx="3391554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551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2948" y="194734"/>
            <a:ext cx="9069705" cy="7069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948" y="973666"/>
            <a:ext cx="9069705" cy="2320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2948" y="3390054"/>
            <a:ext cx="236601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36FC3-9929-854B-9730-29B0F7E46402}" type="datetimeFigureOut">
              <a:rPr lang="en-US" smtClean="0"/>
              <a:t>9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83293" y="3390054"/>
            <a:ext cx="3549015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26643" y="3390054"/>
            <a:ext cx="236601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7E456-D187-A042-B927-3DC0E7598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884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25" r:id="rId1"/>
    <p:sldLayoutId id="2147483926" r:id="rId2"/>
    <p:sldLayoutId id="2147483927" r:id="rId3"/>
    <p:sldLayoutId id="2147483928" r:id="rId4"/>
    <p:sldLayoutId id="2147483929" r:id="rId5"/>
    <p:sldLayoutId id="2147483930" r:id="rId6"/>
    <p:sldLayoutId id="2147483931" r:id="rId7"/>
    <p:sldLayoutId id="2147483932" r:id="rId8"/>
    <p:sldLayoutId id="2147483933" r:id="rId9"/>
    <p:sldLayoutId id="2147483934" r:id="rId10"/>
    <p:sldLayoutId id="2147483935" r:id="rId11"/>
  </p:sldLayoutIdLst>
  <p:txStyles>
    <p:titleStyle>
      <a:lvl1pPr algn="l" defTabSz="487650" rtl="0" eaLnBrk="1" latinLnBrk="0" hangingPunct="1">
        <a:lnSpc>
          <a:spcPct val="90000"/>
        </a:lnSpc>
        <a:spcBef>
          <a:spcPct val="0"/>
        </a:spcBef>
        <a:buNone/>
        <a:defRPr sz="23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912" indent="-121912" algn="l" defTabSz="48765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1pPr>
      <a:lvl2pPr marL="36573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280" kern="1200">
          <a:solidFill>
            <a:schemeClr val="tx1"/>
          </a:solidFill>
          <a:latin typeface="+mn-lt"/>
          <a:ea typeface="+mn-ea"/>
          <a:cs typeface="+mn-cs"/>
        </a:defRPr>
      </a:lvl2pPr>
      <a:lvl3pPr marL="609562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067" kern="1200">
          <a:solidFill>
            <a:schemeClr val="tx1"/>
          </a:solidFill>
          <a:latin typeface="+mn-lt"/>
          <a:ea typeface="+mn-ea"/>
          <a:cs typeface="+mn-cs"/>
        </a:defRPr>
      </a:lvl3pPr>
      <a:lvl4pPr marL="85338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1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34103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58486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82868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2072510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1pPr>
      <a:lvl2pPr marL="243825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8765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3pPr>
      <a:lvl4pPr marL="73147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97529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21912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46294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706773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1950598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85B52184-C0FA-4008-AB91-34A36208EDFC}"/>
              </a:ext>
            </a:extLst>
          </p:cNvPr>
          <p:cNvSpPr txBox="1"/>
          <p:nvPr/>
        </p:nvSpPr>
        <p:spPr>
          <a:xfrm>
            <a:off x="2804914" y="0"/>
            <a:ext cx="43140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Helvetica" pitchFamily="2" charset="0"/>
              </a:rPr>
              <a:t>Alpha diversity rarefaction curves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E8869E3-9326-4CC5-833F-B90BB8829FDC}"/>
              </a:ext>
            </a:extLst>
          </p:cNvPr>
          <p:cNvGrpSpPr/>
          <p:nvPr/>
        </p:nvGrpSpPr>
        <p:grpSpPr>
          <a:xfrm>
            <a:off x="152374" y="400110"/>
            <a:ext cx="10207926" cy="3231844"/>
            <a:chOff x="688388" y="1880416"/>
            <a:chExt cx="10207926" cy="3231844"/>
          </a:xfrm>
        </p:grpSpPr>
        <p:pic>
          <p:nvPicPr>
            <p:cNvPr id="4" name="Google Shape;69;p15">
              <a:extLst>
                <a:ext uri="{FF2B5EF4-FFF2-40B4-BE49-F238E27FC236}">
                  <a16:creationId xmlns:a16="http://schemas.microsoft.com/office/drawing/2014/main" id="{2F1BF543-6DEB-476D-97FA-070222800B52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r="15751"/>
            <a:stretch/>
          </p:blipFill>
          <p:spPr>
            <a:xfrm>
              <a:off x="865751" y="1880416"/>
              <a:ext cx="4321951" cy="309920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Google Shape;71;p15">
              <a:extLst>
                <a:ext uri="{FF2B5EF4-FFF2-40B4-BE49-F238E27FC236}">
                  <a16:creationId xmlns:a16="http://schemas.microsoft.com/office/drawing/2014/main" id="{07D40D79-7D4B-418E-AF13-E2C081C77206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r="10815"/>
            <a:stretch/>
          </p:blipFill>
          <p:spPr>
            <a:xfrm>
              <a:off x="5808146" y="1889943"/>
              <a:ext cx="4459804" cy="309920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D7D32FD-F730-4485-AB36-E925D8DCAE1D}"/>
                </a:ext>
              </a:extLst>
            </p:cNvPr>
            <p:cNvSpPr txBox="1"/>
            <p:nvPr/>
          </p:nvSpPr>
          <p:spPr>
            <a:xfrm>
              <a:off x="10176803" y="3179243"/>
              <a:ext cx="6126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Helvetica" pitchFamily="2" charset="0"/>
                </a:rPr>
                <a:t>GIFU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0419A4E-46DD-43F8-B5C0-5F15487C39BA}"/>
                </a:ext>
              </a:extLst>
            </p:cNvPr>
            <p:cNvSpPr txBox="1"/>
            <p:nvPr/>
          </p:nvSpPr>
          <p:spPr>
            <a:xfrm>
              <a:off x="10184260" y="3369743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err="1">
                  <a:latin typeface="Helvetica" pitchFamily="2" charset="0"/>
                </a:rPr>
                <a:t>pGIFU</a:t>
              </a:r>
              <a:endParaRPr lang="en-US" sz="1400" dirty="0">
                <a:latin typeface="Helvetica" pitchFamily="2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07469FB-2746-4BC8-A3E0-ECF6ED93BAB8}"/>
                </a:ext>
              </a:extLst>
            </p:cNvPr>
            <p:cNvSpPr txBox="1"/>
            <p:nvPr/>
          </p:nvSpPr>
          <p:spPr>
            <a:xfrm>
              <a:off x="2064919" y="4804483"/>
              <a:ext cx="20152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Helvetica" pitchFamily="2" charset="0"/>
                </a:rPr>
                <a:t>Sequences per sampl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4829AFA-A038-4B85-B74C-95501147353D}"/>
                </a:ext>
              </a:extLst>
            </p:cNvPr>
            <p:cNvSpPr txBox="1"/>
            <p:nvPr/>
          </p:nvSpPr>
          <p:spPr>
            <a:xfrm>
              <a:off x="7151269" y="4804483"/>
              <a:ext cx="20152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Helvetica" pitchFamily="2" charset="0"/>
                </a:rPr>
                <a:t>Sequences per sample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BBC9CBD-4F24-4A55-A756-DBC58BA46E79}"/>
                </a:ext>
              </a:extLst>
            </p:cNvPr>
            <p:cNvSpPr txBox="1"/>
            <p:nvPr/>
          </p:nvSpPr>
          <p:spPr>
            <a:xfrm rot="16200000">
              <a:off x="103132" y="3215854"/>
              <a:ext cx="1478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Helvetica" pitchFamily="2" charset="0"/>
                </a:rPr>
                <a:t>Observed OTUs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B9C6E09-D0A5-4065-A2FD-D227D2FC5F72}"/>
                </a:ext>
              </a:extLst>
            </p:cNvPr>
            <p:cNvSpPr txBox="1"/>
            <p:nvPr/>
          </p:nvSpPr>
          <p:spPr>
            <a:xfrm rot="16200000">
              <a:off x="5429725" y="3215854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Helvetica" pitchFamily="2" charset="0"/>
                </a:rPr>
                <a:t>Chao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56997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638</TotalTime>
  <Words>15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mmary –  Microbe Exposed Medias</dc:title>
  <dc:creator>Jaclyn L</dc:creator>
  <cp:lastModifiedBy>Jaclyn L</cp:lastModifiedBy>
  <cp:revision>142</cp:revision>
  <cp:lastPrinted>2018-10-17T05:07:00Z</cp:lastPrinted>
  <dcterms:created xsi:type="dcterms:W3CDTF">2017-11-13T18:59:57Z</dcterms:created>
  <dcterms:modified xsi:type="dcterms:W3CDTF">2020-09-06T21:00:43Z</dcterms:modified>
</cp:coreProperties>
</file>